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599988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3" d="100"/>
          <a:sy n="53" d="100"/>
        </p:scale>
        <p:origin x="1108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1472842"/>
            <a:ext cx="1070999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4726842"/>
            <a:ext cx="9449991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89723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51578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479142"/>
            <a:ext cx="2716872" cy="762669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479142"/>
            <a:ext cx="7993117" cy="7626692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75969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43294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2243638"/>
            <a:ext cx="10867490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6022610"/>
            <a:ext cx="10867490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03368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2395710"/>
            <a:ext cx="5354995" cy="571012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2395710"/>
            <a:ext cx="5354995" cy="571012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90114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479144"/>
            <a:ext cx="10867490" cy="173949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2206137"/>
            <a:ext cx="5330385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3287331"/>
            <a:ext cx="5330385" cy="483516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2206137"/>
            <a:ext cx="5356636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3287331"/>
            <a:ext cx="5356636" cy="483516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2152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23058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27316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99969"/>
            <a:ext cx="4063824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295769"/>
            <a:ext cx="6378744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699862"/>
            <a:ext cx="4063824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34648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99969"/>
            <a:ext cx="4063824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295769"/>
            <a:ext cx="6378744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699862"/>
            <a:ext cx="4063824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11804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479144"/>
            <a:ext cx="1086749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2395710"/>
            <a:ext cx="1086749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8341240"/>
            <a:ext cx="283499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0269E7-E64E-46FD-87E8-A1F28AB2576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8341240"/>
            <a:ext cx="425249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8341240"/>
            <a:ext cx="283499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776DC6-75F9-4D7C-9D1D-47F3649538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70813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99967" rtl="1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r" defTabSz="1199967" rtl="1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r" defTabSz="1199967" rtl="1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r" defTabSz="1199967" rtl="1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r" defTabSz="1199967" rtl="1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r" defTabSz="1199967" rtl="1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r" defTabSz="1199967" rtl="1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r" defTabSz="1199967" rtl="1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r" defTabSz="1199967" rtl="1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r" defTabSz="1199967" rtl="1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1199967" rtl="1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r" defTabSz="1199967" rtl="1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r" defTabSz="1199967" rtl="1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r" defTabSz="1199967" rtl="1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r" defTabSz="1199967" rtl="1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r" defTabSz="1199967" rtl="1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r" defTabSz="1199967" rtl="1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r" defTabSz="1199967" rtl="1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r" defTabSz="1199967" rtl="1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203995" y="148729"/>
            <a:ext cx="12191999" cy="8702080"/>
            <a:chOff x="0" y="0"/>
            <a:chExt cx="12191999" cy="8702080"/>
          </a:xfrm>
        </p:grpSpPr>
        <p:pic>
          <p:nvPicPr>
            <p:cNvPr id="18" name="תמונה 10">
              <a:extLst>
                <a:ext uri="{FF2B5EF4-FFF2-40B4-BE49-F238E27FC236}">
                  <a16:creationId xmlns:a16="http://schemas.microsoft.com/office/drawing/2014/main" id="{38BB1B51-EECD-43A8-BA93-E7EDD6D2B93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043" y="652996"/>
              <a:ext cx="3988978" cy="2700000"/>
            </a:xfrm>
            <a:prstGeom prst="rect">
              <a:avLst/>
            </a:prstGeom>
          </p:spPr>
        </p:pic>
        <p:sp>
          <p:nvSpPr>
            <p:cNvPr id="19" name="Rectangle 3">
              <a:extLst>
                <a:ext uri="{FF2B5EF4-FFF2-40B4-BE49-F238E27FC236}">
                  <a16:creationId xmlns:a16="http://schemas.microsoft.com/office/drawing/2014/main" id="{33550CB5-5EF0-4F3E-92B2-EBBF51DDB500}"/>
                </a:ext>
              </a:extLst>
            </p:cNvPr>
            <p:cNvSpPr/>
            <p:nvPr/>
          </p:nvSpPr>
          <p:spPr>
            <a:xfrm>
              <a:off x="120072" y="0"/>
              <a:ext cx="12071927" cy="72943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36195" indent="180340" algn="just">
                <a:lnSpc>
                  <a:spcPct val="115000"/>
                </a:lnSpc>
                <a:spcAft>
                  <a:spcPts val="0"/>
                </a:spcAft>
              </a:pPr>
              <a:r>
                <a:rPr lang="en-US" b="1" dirty="0">
                  <a:latin typeface="Times New Roman" panose="02020603050405020304" pitchFamily="18" charset="0"/>
                </a:rPr>
                <a:t>Figure </a:t>
              </a:r>
              <a:r>
                <a:rPr lang="en-US" b="1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S3</a:t>
              </a:r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: A-F) Electrochemical behavior of 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six MFCs, </a:t>
              </a:r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indicating the time at which the bulk liquid was changed. All MFCs started initially with bicarbonate 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buffer and acetate as the </a:t>
              </a:r>
              <a:r>
                <a:rPr lang="en-US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electron donor.     </a:t>
              </a:r>
              <a:endParaRPr lang="en-US" dirty="0">
                <a:latin typeface="Times New Roman" panose="02020603050405020304" pitchFamily="18" charset="0"/>
                <a:cs typeface="David" panose="020E0502060401010101" pitchFamily="34" charset="-79"/>
              </a:endParaRPr>
            </a:p>
          </p:txBody>
        </p:sp>
        <p:grpSp>
          <p:nvGrpSpPr>
            <p:cNvPr id="20" name="קבוצה 1">
              <a:extLst>
                <a:ext uri="{FF2B5EF4-FFF2-40B4-BE49-F238E27FC236}">
                  <a16:creationId xmlns:a16="http://schemas.microsoft.com/office/drawing/2014/main" id="{66A34B27-0C02-4B5A-A3D2-58793352FE11}"/>
                </a:ext>
              </a:extLst>
            </p:cNvPr>
            <p:cNvGrpSpPr/>
            <p:nvPr/>
          </p:nvGrpSpPr>
          <p:grpSpPr>
            <a:xfrm>
              <a:off x="0" y="3209546"/>
              <a:ext cx="12079467" cy="2792534"/>
              <a:chOff x="0" y="737564"/>
              <a:chExt cx="12079467" cy="2792534"/>
            </a:xfrm>
          </p:grpSpPr>
          <p:pic>
            <p:nvPicPr>
              <p:cNvPr id="27" name="תמונה 4">
                <a:extLst>
                  <a:ext uri="{FF2B5EF4-FFF2-40B4-BE49-F238E27FC236}">
                    <a16:creationId xmlns:a16="http://schemas.microsoft.com/office/drawing/2014/main" id="{28448C21-675E-464A-BDE6-31FFDF54278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01511" y="830098"/>
                <a:ext cx="3988978" cy="2700000"/>
              </a:xfrm>
              <a:prstGeom prst="rect">
                <a:avLst/>
              </a:prstGeom>
            </p:spPr>
          </p:pic>
          <p:pic>
            <p:nvPicPr>
              <p:cNvPr id="28" name="תמונה 6">
                <a:extLst>
                  <a:ext uri="{FF2B5EF4-FFF2-40B4-BE49-F238E27FC236}">
                    <a16:creationId xmlns:a16="http://schemas.microsoft.com/office/drawing/2014/main" id="{D08AE9DE-6A72-4AAA-9E02-FAC47B0649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90489" y="830098"/>
                <a:ext cx="3988978" cy="2700000"/>
              </a:xfrm>
              <a:prstGeom prst="rect">
                <a:avLst/>
              </a:prstGeom>
            </p:spPr>
          </p:pic>
          <p:pic>
            <p:nvPicPr>
              <p:cNvPr id="29" name="תמונה 8">
                <a:extLst>
                  <a:ext uri="{FF2B5EF4-FFF2-40B4-BE49-F238E27FC236}">
                    <a16:creationId xmlns:a16="http://schemas.microsoft.com/office/drawing/2014/main" id="{9952C9D3-2E03-4F09-B3CD-2E51AD4D50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2338" y="830098"/>
                <a:ext cx="3988978" cy="2700000"/>
              </a:xfrm>
              <a:prstGeom prst="rect">
                <a:avLst/>
              </a:prstGeom>
            </p:spPr>
          </p:pic>
          <p:sp>
            <p:nvSpPr>
              <p:cNvPr id="30" name="מלבן 15">
                <a:extLst>
                  <a:ext uri="{FF2B5EF4-FFF2-40B4-BE49-F238E27FC236}">
                    <a16:creationId xmlns:a16="http://schemas.microsoft.com/office/drawing/2014/main" id="{8EC0F3F6-BEB7-4974-A865-880ACBE672AF}"/>
                  </a:ext>
                </a:extLst>
              </p:cNvPr>
              <p:cNvSpPr/>
              <p:nvPr/>
            </p:nvSpPr>
            <p:spPr>
              <a:xfrm>
                <a:off x="0" y="737564"/>
                <a:ext cx="332142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B</a:t>
                </a:r>
                <a:endParaRPr lang="he-IL" sz="1600" dirty="0"/>
              </a:p>
            </p:txBody>
          </p:sp>
          <p:sp>
            <p:nvSpPr>
              <p:cNvPr id="31" name="מלבן 16">
                <a:extLst>
                  <a:ext uri="{FF2B5EF4-FFF2-40B4-BE49-F238E27FC236}">
                    <a16:creationId xmlns:a16="http://schemas.microsoft.com/office/drawing/2014/main" id="{F4A57D06-2E73-4C5D-9C03-13A41745B372}"/>
                  </a:ext>
                </a:extLst>
              </p:cNvPr>
              <p:cNvSpPr/>
              <p:nvPr/>
            </p:nvSpPr>
            <p:spPr>
              <a:xfrm>
                <a:off x="3865369" y="737564"/>
                <a:ext cx="332142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endParaRPr lang="he-IL" sz="1600" dirty="0"/>
              </a:p>
            </p:txBody>
          </p:sp>
          <p:sp>
            <p:nvSpPr>
              <p:cNvPr id="32" name="מלבן 17">
                <a:extLst>
                  <a:ext uri="{FF2B5EF4-FFF2-40B4-BE49-F238E27FC236}">
                    <a16:creationId xmlns:a16="http://schemas.microsoft.com/office/drawing/2014/main" id="{B329A339-A8C7-4765-9C13-F728D6DF76A0}"/>
                  </a:ext>
                </a:extLst>
              </p:cNvPr>
              <p:cNvSpPr/>
              <p:nvPr/>
            </p:nvSpPr>
            <p:spPr>
              <a:xfrm>
                <a:off x="7920248" y="737564"/>
                <a:ext cx="332142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D</a:t>
                </a:r>
                <a:endParaRPr lang="he-IL" sz="1600" dirty="0"/>
              </a:p>
            </p:txBody>
          </p:sp>
        </p:grpSp>
        <p:grpSp>
          <p:nvGrpSpPr>
            <p:cNvPr id="21" name="קבוצה 3">
              <a:extLst>
                <a:ext uri="{FF2B5EF4-FFF2-40B4-BE49-F238E27FC236}">
                  <a16:creationId xmlns:a16="http://schemas.microsoft.com/office/drawing/2014/main" id="{C480FBD6-1D4B-417E-8EB7-F9D4BDFAA163}"/>
                </a:ext>
              </a:extLst>
            </p:cNvPr>
            <p:cNvGrpSpPr/>
            <p:nvPr/>
          </p:nvGrpSpPr>
          <p:grpSpPr>
            <a:xfrm>
              <a:off x="0" y="5985456"/>
              <a:ext cx="8090489" cy="2716624"/>
              <a:chOff x="0" y="3513474"/>
              <a:chExt cx="8090489" cy="2716624"/>
            </a:xfrm>
          </p:grpSpPr>
          <p:pic>
            <p:nvPicPr>
              <p:cNvPr id="23" name="תמונה 2">
                <a:extLst>
                  <a:ext uri="{FF2B5EF4-FFF2-40B4-BE49-F238E27FC236}">
                    <a16:creationId xmlns:a16="http://schemas.microsoft.com/office/drawing/2014/main" id="{B1D436E5-4BD1-48AC-B33B-A630A97441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5043" y="3513474"/>
                <a:ext cx="3988978" cy="2700000"/>
              </a:xfrm>
              <a:prstGeom prst="rect">
                <a:avLst/>
              </a:prstGeom>
            </p:spPr>
          </p:pic>
          <p:pic>
            <p:nvPicPr>
              <p:cNvPr id="24" name="תמונה 12">
                <a:extLst>
                  <a:ext uri="{FF2B5EF4-FFF2-40B4-BE49-F238E27FC236}">
                    <a16:creationId xmlns:a16="http://schemas.microsoft.com/office/drawing/2014/main" id="{41AC4395-24AA-4946-9C65-D314DB11CA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01511" y="3530098"/>
                <a:ext cx="3988978" cy="2700000"/>
              </a:xfrm>
              <a:prstGeom prst="rect">
                <a:avLst/>
              </a:prstGeom>
            </p:spPr>
          </p:pic>
          <p:sp>
            <p:nvSpPr>
              <p:cNvPr id="25" name="מלבן 18">
                <a:extLst>
                  <a:ext uri="{FF2B5EF4-FFF2-40B4-BE49-F238E27FC236}">
                    <a16:creationId xmlns:a16="http://schemas.microsoft.com/office/drawing/2014/main" id="{06BB4632-36CF-467F-BD12-4E02FE1D18A4}"/>
                  </a:ext>
                </a:extLst>
              </p:cNvPr>
              <p:cNvSpPr/>
              <p:nvPr/>
            </p:nvSpPr>
            <p:spPr>
              <a:xfrm>
                <a:off x="0" y="3513474"/>
                <a:ext cx="309700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E</a:t>
                </a:r>
                <a:endParaRPr lang="he-IL" sz="1600" dirty="0"/>
              </a:p>
            </p:txBody>
          </p:sp>
          <p:sp>
            <p:nvSpPr>
              <p:cNvPr id="26" name="מלבן 19">
                <a:extLst>
                  <a:ext uri="{FF2B5EF4-FFF2-40B4-BE49-F238E27FC236}">
                    <a16:creationId xmlns:a16="http://schemas.microsoft.com/office/drawing/2014/main" id="{F802E924-B936-4220-80E5-B091C453307E}"/>
                  </a:ext>
                </a:extLst>
              </p:cNvPr>
              <p:cNvSpPr/>
              <p:nvPr/>
            </p:nvSpPr>
            <p:spPr>
              <a:xfrm>
                <a:off x="3887811" y="3546722"/>
                <a:ext cx="309700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F</a:t>
                </a:r>
                <a:endParaRPr lang="he-IL" sz="1600" dirty="0"/>
              </a:p>
            </p:txBody>
          </p:sp>
        </p:grpSp>
        <p:sp>
          <p:nvSpPr>
            <p:cNvPr id="22" name="מלבן 21">
              <a:extLst>
                <a:ext uri="{FF2B5EF4-FFF2-40B4-BE49-F238E27FC236}">
                  <a16:creationId xmlns:a16="http://schemas.microsoft.com/office/drawing/2014/main" id="{4BFEA47B-0CD4-472C-A397-172C5DC84F79}"/>
                </a:ext>
              </a:extLst>
            </p:cNvPr>
            <p:cNvSpPr/>
            <p:nvPr/>
          </p:nvSpPr>
          <p:spPr>
            <a:xfrm>
              <a:off x="0" y="703911"/>
              <a:ext cx="33214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A</a:t>
              </a:r>
              <a:endParaRPr lang="he-IL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2975228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42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David</vt:lpstr>
      <vt:lpstr>Times New Roman</vt:lpstr>
      <vt:lpstr>Office Theme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en Yanuka-Golub</dc:creator>
  <cp:lastModifiedBy>Keren Yanuka-Golub</cp:lastModifiedBy>
  <cp:revision>1</cp:revision>
  <dcterms:created xsi:type="dcterms:W3CDTF">2020-02-16T09:18:05Z</dcterms:created>
  <dcterms:modified xsi:type="dcterms:W3CDTF">2020-02-16T09:23:24Z</dcterms:modified>
</cp:coreProperties>
</file>